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9CB216-A8D6-411A-906A-B294F7AA8E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4473161-EDAB-4E68-853E-25591478D5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91E2D2-6112-42D6-9F7F-D807D6D33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39B372-B331-43A5-AFF9-613FA6154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47DC8F-551B-4CE1-91E6-E71AF23A2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277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D81115-479A-401F-A873-52A885D2A5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02A917A-8A44-4305-872C-C75366189F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51FC9E-B2D9-4D14-BA83-2EE2D9BDB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3762A3-6F37-46F4-9958-E9755718B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063995-56A3-408E-BC5D-891696C17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1139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7AFAAAB-40E8-4E80-829B-EE599831A8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CA3E348-AB78-4C83-A6AF-88FC47116F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2A9B7C-2835-4C34-A5CB-4DDBB4FD8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DA431F-6260-41B2-8A89-AFF8E7404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919C159-EB90-4782-83AF-B7296B7E9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77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74DF46-A410-4DC4-B522-1DE8DEFEF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5AF9494-0BEF-4385-A8F9-17BA68F0A7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D311D6-A351-4EFC-A0B7-0394612FD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32E319-9849-45F3-8AC5-C9B9C7454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8E064A-6B17-461A-AF83-4CD263977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737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9E551F-55C4-482E-8BE2-7CCB7AE00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B2BEB0-7BDE-4BF4-880C-6B9939F47B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3F2D10-8438-4523-BD9A-C70FC03DE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8A2FD4-B57E-49A4-BFFC-4CE21B1E0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E8EE48-57BC-455D-A742-8762BEF8E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390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EA1BDB-B449-4CEF-903D-4B8B2DB3E1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E5704D-F773-4DFC-B49D-A1BEAAC971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E61B454-5C5A-489B-82ED-49FEE4524A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427FD7-A0D9-4561-A72E-6489173E3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CA1114-10B4-46A0-B777-A27738206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C26AC66-7433-4665-B5D2-3F8D1739E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599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5F6D8D-D699-49F0-8D72-49ABCB2B2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19B9E1-9C1F-4012-AAEC-E733C0FB8D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7B5F157-F101-461F-A7FC-CF3136987A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6AF1E74-8D84-49C4-9B7F-C057AC9AC4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B275C79-D0D2-4F08-A207-B5A2F0914F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A319CF9-B63E-46E8-B70F-02207763E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22EF275-D34E-4AD2-AC47-086F51B05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356BEA8-61D7-4C1C-A731-63A101F71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221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4E2DF2-49B9-4E09-B2C5-E783AA6C3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2DED4FE-C5B2-474A-813C-7802CA16F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2DA3404-623A-47DB-B090-4A5A0A311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B579A38-0B42-4CA8-9DD4-7859D2EB8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235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236EC19-FE87-436D-AD85-A9C551E61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8B3A496-007B-4E91-9A0E-E8FAB7B4D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A53CDC-BFE3-4FA9-88E0-0240A9C5C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8749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D71C60-0966-4BAE-8867-50359E5E2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48F6E64-B3AE-4E61-AA17-0FF564C9DD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CC9D77D-02B8-4ABD-8BE1-E78B5CD0ED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86A546-DAF2-43DD-9DF8-89C0524C8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54AF584-F45C-41DB-825F-1A1829DA4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7072A03-6817-4586-9CD9-337218F83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06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27897F-46B9-4DDD-8AC2-DC77510D90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F88310A-008F-4124-A8F3-EA5A8294DA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A781692-FBA6-4620-824A-E62A90F1B2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7AD0EEE-8C41-4F2C-831E-EC281A434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9C5A7F-A8B5-4E1E-AF32-23F4D2CCA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F38C4A0-75BD-41B4-9139-3D1D1A7A8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4026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45A2177-BDD1-428D-A47E-78FFE065C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5CD953-58CC-4F30-B238-D0E9689BCF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91157B-6EAA-4916-8F83-0900B41F39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17703-C012-4D9E-8340-BE3450DAB96B}" type="datetimeFigureOut">
              <a:rPr kumimoji="1" lang="ja-JP" altLang="en-US" smtClean="0"/>
              <a:t>2020/9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8F59BB-A4F3-435A-81A7-1E12645351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ABE030-2327-41D9-9206-48AB8B6F38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D4C92-B0C7-4909-A387-16CEF9E3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510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21234E8-E486-4C1D-BFBF-6978A2417E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0035" y="740883"/>
            <a:ext cx="2195802" cy="231761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98699DA-2F47-40DE-BECD-49A7F8EDBC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9668" y="715912"/>
            <a:ext cx="2494014" cy="246235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4839121-12A3-4022-864B-3E7684E3CF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85952" y="710818"/>
            <a:ext cx="2634603" cy="2433598"/>
          </a:xfrm>
          <a:prstGeom prst="rect">
            <a:avLst/>
          </a:prstGeom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1DBE2425-9785-47C4-8A52-2162322BA1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197" y="3666930"/>
            <a:ext cx="2306285" cy="23143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50B227A-3CB3-457A-91C9-D4E9DA39E89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95434" y="3704253"/>
            <a:ext cx="2430926" cy="2285999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7410151-799C-4A38-9C72-00F958BAC76D}"/>
              </a:ext>
            </a:extLst>
          </p:cNvPr>
          <p:cNvSpPr txBox="1"/>
          <p:nvPr/>
        </p:nvSpPr>
        <p:spPr>
          <a:xfrm>
            <a:off x="6363478" y="3582955"/>
            <a:ext cx="4289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Sequential pictures</a:t>
            </a:r>
            <a:r>
              <a:rPr lang="ja-JP" altLang="en-US" dirty="0">
                <a:latin typeface="Palatino Linotype" panose="02040502050505030304" pitchFamily="18" charset="0"/>
              </a:rPr>
              <a:t> </a:t>
            </a:r>
            <a:r>
              <a:rPr lang="en-US" altLang="ja-JP" dirty="0">
                <a:latin typeface="Palatino Linotype" panose="02040502050505030304" pitchFamily="18" charset="0"/>
              </a:rPr>
              <a:t>of</a:t>
            </a:r>
            <a:r>
              <a:rPr lang="ja-JP" altLang="en-US" dirty="0">
                <a:latin typeface="Palatino Linotype" panose="02040502050505030304" pitchFamily="18" charset="0"/>
              </a:rPr>
              <a:t> </a:t>
            </a:r>
            <a:r>
              <a:rPr lang="en-US" altLang="ja-JP" dirty="0">
                <a:latin typeface="Palatino Linotype" panose="02040502050505030304" pitchFamily="18" charset="0"/>
              </a:rPr>
              <a:t>mucosal</a:t>
            </a:r>
            <a:r>
              <a:rPr lang="ja-JP" altLang="en-US" dirty="0">
                <a:latin typeface="Palatino Linotype" panose="02040502050505030304" pitchFamily="18" charset="0"/>
              </a:rPr>
              <a:t> </a:t>
            </a:r>
            <a:r>
              <a:rPr lang="en-US" altLang="ja-JP" dirty="0">
                <a:latin typeface="Palatino Linotype" panose="02040502050505030304" pitchFamily="18" charset="0"/>
              </a:rPr>
              <a:t>brushing</a:t>
            </a:r>
            <a:endParaRPr kumimoji="1" lang="en-US" altLang="ja-JP" dirty="0">
              <a:latin typeface="Palatino Linotype" panose="0204050205050503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3FDDB28-6DFE-42A6-8CA1-3C3A833CC3E3}"/>
              </a:ext>
            </a:extLst>
          </p:cNvPr>
          <p:cNvSpPr txBox="1"/>
          <p:nvPr/>
        </p:nvSpPr>
        <p:spPr>
          <a:xfrm>
            <a:off x="597159" y="214604"/>
            <a:ext cx="6286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Palatino Linotype" panose="02040502050505030304" pitchFamily="18" charset="0"/>
              </a:rPr>
              <a:t>(A)</a:t>
            </a:r>
            <a:endParaRPr kumimoji="1" lang="ja-JP" altLang="en-US" sz="2400" dirty="0">
              <a:latin typeface="Palatino Linotype" panose="0204050205050503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1BD9F48-27D2-446D-A3D8-7CF1B32AB3F4}"/>
              </a:ext>
            </a:extLst>
          </p:cNvPr>
          <p:cNvSpPr txBox="1"/>
          <p:nvPr/>
        </p:nvSpPr>
        <p:spPr>
          <a:xfrm>
            <a:off x="684245" y="3175517"/>
            <a:ext cx="6286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Palatino Linotype" panose="02040502050505030304" pitchFamily="18" charset="0"/>
              </a:rPr>
              <a:t>(D)</a:t>
            </a:r>
            <a:endParaRPr kumimoji="1" lang="ja-JP" altLang="en-US" sz="2400" dirty="0">
              <a:latin typeface="Palatino Linotype" panose="0204050205050503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B39355E-243F-4DA1-A711-BCDEFDF39F72}"/>
              </a:ext>
            </a:extLst>
          </p:cNvPr>
          <p:cNvSpPr txBox="1"/>
          <p:nvPr/>
        </p:nvSpPr>
        <p:spPr>
          <a:xfrm>
            <a:off x="5884506" y="192833"/>
            <a:ext cx="6078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Palatino Linotype" panose="02040502050505030304" pitchFamily="18" charset="0"/>
              </a:rPr>
              <a:t>(C)</a:t>
            </a:r>
            <a:endParaRPr kumimoji="1" lang="ja-JP" altLang="en-US" sz="2400" dirty="0">
              <a:latin typeface="Palatino Linotype" panose="0204050205050503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AB70C6A-5A7B-44AB-B4F7-F99864FA63AF}"/>
              </a:ext>
            </a:extLst>
          </p:cNvPr>
          <p:cNvSpPr txBox="1"/>
          <p:nvPr/>
        </p:nvSpPr>
        <p:spPr>
          <a:xfrm>
            <a:off x="3125755" y="186612"/>
            <a:ext cx="5774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Palatino Linotype" panose="02040502050505030304" pitchFamily="18" charset="0"/>
              </a:rPr>
              <a:t>(B)</a:t>
            </a:r>
            <a:endParaRPr kumimoji="1" lang="ja-JP" altLang="en-US" sz="2400" dirty="0">
              <a:latin typeface="Palatino Linotype" panose="0204050205050503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966E855-5EB8-4A2D-B64F-B7AAC9B32090}"/>
              </a:ext>
            </a:extLst>
          </p:cNvPr>
          <p:cNvSpPr txBox="1"/>
          <p:nvPr/>
        </p:nvSpPr>
        <p:spPr>
          <a:xfrm>
            <a:off x="3079102" y="3219061"/>
            <a:ext cx="5774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Palatino Linotype" panose="02040502050505030304" pitchFamily="18" charset="0"/>
              </a:rPr>
              <a:t>(E)</a:t>
            </a:r>
            <a:endParaRPr kumimoji="1" lang="ja-JP" altLang="en-US" sz="2400" dirty="0">
              <a:latin typeface="Palatino Linotype" panose="0204050205050503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698B9D0-BA92-49FC-8A28-AB6D1B03D96C}"/>
              </a:ext>
            </a:extLst>
          </p:cNvPr>
          <p:cNvSpPr txBox="1"/>
          <p:nvPr/>
        </p:nvSpPr>
        <p:spPr>
          <a:xfrm>
            <a:off x="6727371" y="4432041"/>
            <a:ext cx="204254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lphaUcParenBoth"/>
            </a:pPr>
            <a:r>
              <a:rPr lang="en-US" altLang="ja-JP" dirty="0">
                <a:latin typeface="Palatino Linotype" panose="02040502050505030304" pitchFamily="18" charset="0"/>
              </a:rPr>
              <a:t>Tongue</a:t>
            </a:r>
          </a:p>
          <a:p>
            <a:pPr marL="342900" indent="-342900">
              <a:buAutoNum type="alphaUcParenBoth"/>
            </a:pPr>
            <a:r>
              <a:rPr lang="en-US" altLang="ja-JP" dirty="0" err="1">
                <a:latin typeface="Palatino Linotype" panose="02040502050505030304" pitchFamily="18" charset="0"/>
              </a:rPr>
              <a:t>Palatum</a:t>
            </a:r>
            <a:endParaRPr lang="en-US" altLang="ja-JP" dirty="0">
              <a:latin typeface="Palatino Linotype" panose="02040502050505030304" pitchFamily="18" charset="0"/>
            </a:endParaRPr>
          </a:p>
          <a:p>
            <a:pPr marL="342900" indent="-342900">
              <a:buAutoNum type="alphaUcParenBoth"/>
            </a:pPr>
            <a:r>
              <a:rPr kumimoji="1" lang="en-US" altLang="ja-JP" dirty="0">
                <a:latin typeface="Palatino Linotype" panose="02040502050505030304" pitchFamily="18" charset="0"/>
              </a:rPr>
              <a:t>Teeth</a:t>
            </a:r>
          </a:p>
          <a:p>
            <a:pPr marL="342900" indent="-342900">
              <a:buAutoNum type="alphaUcParenBoth"/>
            </a:pPr>
            <a:r>
              <a:rPr lang="en-US" altLang="ja-JP" dirty="0">
                <a:latin typeface="Palatino Linotype" panose="02040502050505030304" pitchFamily="18" charset="0"/>
              </a:rPr>
              <a:t>Labial mucosa</a:t>
            </a:r>
          </a:p>
          <a:p>
            <a:pPr marL="342900" indent="-342900">
              <a:buAutoNum type="alphaUcParenBoth"/>
            </a:pPr>
            <a:r>
              <a:rPr lang="en-US" altLang="ja-JP" dirty="0">
                <a:latin typeface="Palatino Linotype" panose="02040502050505030304" pitchFamily="18" charset="0"/>
              </a:rPr>
              <a:t>Buccal mucosa</a:t>
            </a:r>
            <a:endParaRPr kumimoji="1" lang="en-US" altLang="ja-JP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3434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7</Words>
  <Application>Microsoft Office PowerPoint</Application>
  <PresentationFormat>ワイド画面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義明 野村</dc:creator>
  <cp:lastModifiedBy>義明 野村</cp:lastModifiedBy>
  <cp:revision>2</cp:revision>
  <dcterms:created xsi:type="dcterms:W3CDTF">2020-09-16T06:47:55Z</dcterms:created>
  <dcterms:modified xsi:type="dcterms:W3CDTF">2020-09-16T06:57:13Z</dcterms:modified>
</cp:coreProperties>
</file>